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ma\Documents\Grant%20applications\Gates%20ETEC%20(April%202018)\Results%20and%20Reports\Glyco-analysis%2019021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76435312"/>
        <c:axId val="276435704"/>
      </c:barChart>
      <c:catAx>
        <c:axId val="27643531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76435704"/>
        <c:crosses val="autoZero"/>
        <c:auto val="1"/>
        <c:lblAlgn val="ctr"/>
        <c:lblOffset val="100"/>
        <c:noMultiLvlLbl val="0"/>
      </c:catAx>
      <c:valAx>
        <c:axId val="2764357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64353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6618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98073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012414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52920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6815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35209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93698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41198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99827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32509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61993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AFD46-BFEA-4138-B90E-220102F3D2F2}" type="datetimeFigureOut">
              <a:rPr lang="en-IN" smtClean="0"/>
              <a:t>12-01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C26BF4-CB82-43C9-BD99-218C47E37EC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98355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18" Type="http://schemas.openxmlformats.org/officeDocument/2006/relationships/oleObject" Target="../embeddings/oleObject8.bin"/><Relationship Id="rId3" Type="http://schemas.openxmlformats.org/officeDocument/2006/relationships/chart" Target="../charts/chart1.xml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w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7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5" Type="http://schemas.openxmlformats.org/officeDocument/2006/relationships/image" Target="../media/image1.wmf"/><Relationship Id="rId15" Type="http://schemas.openxmlformats.org/officeDocument/2006/relationships/image" Target="../media/image6.w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w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emf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17" Type="http://schemas.openxmlformats.org/officeDocument/2006/relationships/image" Target="../media/image24.png"/><Relationship Id="rId2" Type="http://schemas.openxmlformats.org/officeDocument/2006/relationships/image" Target="../media/image9.emf"/><Relationship Id="rId16" Type="http://schemas.openxmlformats.org/officeDocument/2006/relationships/image" Target="../media/image2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emf"/><Relationship Id="rId15" Type="http://schemas.openxmlformats.org/officeDocument/2006/relationships/image" Target="../media/image22.png"/><Relationship Id="rId10" Type="http://schemas.openxmlformats.org/officeDocument/2006/relationships/image" Target="../media/image17.png"/><Relationship Id="rId4" Type="http://schemas.openxmlformats.org/officeDocument/2006/relationships/image" Target="../media/image11.emf"/><Relationship Id="rId9" Type="http://schemas.openxmlformats.org/officeDocument/2006/relationships/image" Target="../media/image16.png"/><Relationship Id="rId14" Type="http://schemas.openxmlformats.org/officeDocument/2006/relationships/image" Target="../media/image2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17" Type="http://schemas.openxmlformats.org/officeDocument/2006/relationships/image" Target="../media/image40.emf"/><Relationship Id="rId2" Type="http://schemas.openxmlformats.org/officeDocument/2006/relationships/image" Target="../media/image25.png"/><Relationship Id="rId16" Type="http://schemas.openxmlformats.org/officeDocument/2006/relationships/image" Target="../media/image3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5" Type="http://schemas.openxmlformats.org/officeDocument/2006/relationships/image" Target="../media/image38.emf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openxmlformats.org/officeDocument/2006/relationships/image" Target="../media/image37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687551" y="200723"/>
            <a:ext cx="2512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uppl. data S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691106" y="300718"/>
            <a:ext cx="50767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u="sng" dirty="0"/>
              <a:t>Size Exclusion Chromatography  analysis of </a:t>
            </a:r>
            <a:r>
              <a:rPr lang="en-GB" u="sng" dirty="0" err="1"/>
              <a:t>SIgAs</a:t>
            </a:r>
            <a:endParaRPr lang="en-GB" i="1" u="sng" dirty="0"/>
          </a:p>
        </p:txBody>
      </p:sp>
      <p:graphicFrame>
        <p:nvGraphicFramePr>
          <p:cNvPr id="13" name="Chart 12"/>
          <p:cNvGraphicFramePr>
            <a:graphicFrameLocks/>
          </p:cNvGraphicFramePr>
          <p:nvPr/>
        </p:nvGraphicFramePr>
        <p:xfrm>
          <a:off x="7892470" y="1938774"/>
          <a:ext cx="2654519" cy="1214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8837FDA1-73A8-4CAF-A044-010EDBCD72C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926604" y="1113951"/>
          <a:ext cx="2397336" cy="183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Graph" r:id="rId4" imgW="3920760" imgH="3000960" progId="Origin50.Graph">
                  <p:embed/>
                </p:oleObj>
              </mc:Choice>
              <mc:Fallback>
                <p:oleObj name="Graph" r:id="rId4" imgW="3920760" imgH="3000960" progId="Origin50.Graph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8837FDA1-73A8-4CAF-A044-010EDBCD72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26604" y="1113951"/>
                        <a:ext cx="2397336" cy="183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37D539F1-45F4-4F57-A333-634239B8F64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817928" y="1091365"/>
          <a:ext cx="2456372" cy="18795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Graph" r:id="rId6" imgW="3920760" imgH="3000960" progId="Origin50.Graph">
                  <p:embed/>
                </p:oleObj>
              </mc:Choice>
              <mc:Fallback>
                <p:oleObj name="Graph" r:id="rId6" imgW="3920760" imgH="3000960" progId="Origin50.Graph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37D539F1-45F4-4F57-A333-634239B8F64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817928" y="1091365"/>
                        <a:ext cx="2456372" cy="18795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ECDBB8D7-5112-4E46-923F-829608C3363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728559" y="1011942"/>
          <a:ext cx="2546512" cy="19485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Graph" r:id="rId8" imgW="3920760" imgH="3000960" progId="Origin50.Graph">
                  <p:embed/>
                </p:oleObj>
              </mc:Choice>
              <mc:Fallback>
                <p:oleObj name="Graph" r:id="rId8" imgW="3920760" imgH="3000960" progId="Origin50.Graph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ECDBB8D7-5112-4E46-923F-829608C3363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728559" y="1011942"/>
                        <a:ext cx="2546512" cy="19485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F30D68D9-F6C8-4F3B-8A8E-20642AE65A5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843784" y="2921438"/>
          <a:ext cx="2480156" cy="18977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Graph" r:id="rId10" imgW="3920760" imgH="3000960" progId="Origin50.Graph">
                  <p:embed/>
                </p:oleObj>
              </mc:Choice>
              <mc:Fallback>
                <p:oleObj name="Graph" r:id="rId10" imgW="3920760" imgH="3000960" progId="Origin50.Graph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F30D68D9-F6C8-4F3B-8A8E-20642AE65A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843784" y="2921438"/>
                        <a:ext cx="2480156" cy="18977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8B182CCF-1472-4791-B802-D0A9FC22C2C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902747" y="2860786"/>
          <a:ext cx="2559422" cy="19584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Graph" r:id="rId12" imgW="3920760" imgH="3000960" progId="Origin50.Graph">
                  <p:embed/>
                </p:oleObj>
              </mc:Choice>
              <mc:Fallback>
                <p:oleObj name="Graph" r:id="rId12" imgW="3920760" imgH="3000960" progId="Origin50.Graph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8B182CCF-1472-4791-B802-D0A9FC22C2C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902747" y="2860786"/>
                        <a:ext cx="2559422" cy="19584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E8460BE5-DA5B-4500-9728-C61ABD5CF7F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766911" y="2960489"/>
          <a:ext cx="2365612" cy="1810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Graph" r:id="rId14" imgW="3920760" imgH="3000960" progId="Origin50.Graph">
                  <p:embed/>
                </p:oleObj>
              </mc:Choice>
              <mc:Fallback>
                <p:oleObj name="Graph" r:id="rId14" imgW="3920760" imgH="3000960" progId="Origin50.Graph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E8460BE5-DA5B-4500-9728-C61ABD5CF7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766911" y="2960489"/>
                        <a:ext cx="2365612" cy="1810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967490B2-92D8-4A22-B6CE-16DBFDE665F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75495" y="2951670"/>
          <a:ext cx="2322109" cy="17766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Graph" r:id="rId16" imgW="3920760" imgH="3000960" progId="Origin50.Graph">
                  <p:embed/>
                </p:oleObj>
              </mc:Choice>
              <mc:Fallback>
                <p:oleObj name="Graph" r:id="rId16" imgW="3920760" imgH="3000960" progId="Origin50.Graph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967490B2-92D8-4A22-B6CE-16DBFDE665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575495" y="2951670"/>
                        <a:ext cx="2322109" cy="17766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FC7EE206-F3C4-478E-BC24-4CDFAE3D5A5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575495" y="1053172"/>
          <a:ext cx="2446541" cy="1871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Graph" r:id="rId18" imgW="3920760" imgH="3000960" progId="Origin50.Graph">
                  <p:embed/>
                </p:oleObj>
              </mc:Choice>
              <mc:Fallback>
                <p:oleObj name="Graph" r:id="rId18" imgW="3920760" imgH="3000960" progId="Origin50.Graph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FC7EE206-F3C4-478E-BC24-4CDFAE3D5A5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575495" y="1053172"/>
                        <a:ext cx="2446541" cy="1871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524000" y="8038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876265" y="8038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6053791" y="8038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975389" y="8038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521173" y="272722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873438" y="272722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050964" y="2727225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972562" y="272722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17830898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67">
            <a:extLst>
              <a:ext uri="{FF2B5EF4-FFF2-40B4-BE49-F238E27FC236}">
                <a16:creationId xmlns:a16="http://schemas.microsoft.com/office/drawing/2014/main" id="{179442FE-754E-4340-8656-412B3A637B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74599" y="345960"/>
            <a:ext cx="1309210" cy="1654216"/>
          </a:xfrm>
          <a:prstGeom prst="rect">
            <a:avLst/>
          </a:prstGeom>
        </p:spPr>
      </p:pic>
      <p:pic>
        <p:nvPicPr>
          <p:cNvPr id="70" name="Picture 69">
            <a:extLst>
              <a:ext uri="{FF2B5EF4-FFF2-40B4-BE49-F238E27FC236}">
                <a16:creationId xmlns:a16="http://schemas.microsoft.com/office/drawing/2014/main" id="{4AD15104-8B9A-4859-AD55-0D56227450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74599" y="2022609"/>
            <a:ext cx="1309210" cy="1654216"/>
          </a:xfrm>
          <a:prstGeom prst="rect">
            <a:avLst/>
          </a:prstGeom>
        </p:spPr>
      </p:pic>
      <p:pic>
        <p:nvPicPr>
          <p:cNvPr id="72" name="Picture 71">
            <a:extLst>
              <a:ext uri="{FF2B5EF4-FFF2-40B4-BE49-F238E27FC236}">
                <a16:creationId xmlns:a16="http://schemas.microsoft.com/office/drawing/2014/main" id="{7E6673A9-9DC7-4DC9-A99F-95D7BC0005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74599" y="3826872"/>
            <a:ext cx="1309210" cy="1249515"/>
          </a:xfrm>
          <a:prstGeom prst="rect">
            <a:avLst/>
          </a:prstGeom>
        </p:spPr>
      </p:pic>
      <p:pic>
        <p:nvPicPr>
          <p:cNvPr id="74" name="Picture 73">
            <a:extLst>
              <a:ext uri="{FF2B5EF4-FFF2-40B4-BE49-F238E27FC236}">
                <a16:creationId xmlns:a16="http://schemas.microsoft.com/office/drawing/2014/main" id="{8B60DA80-692C-4EF4-814B-D4A62AC63D2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74601" y="5626546"/>
            <a:ext cx="1309209" cy="945989"/>
          </a:xfrm>
          <a:prstGeom prst="rect">
            <a:avLst/>
          </a:prstGeom>
        </p:spPr>
      </p:pic>
      <p:sp>
        <p:nvSpPr>
          <p:cNvPr id="75" name="TextBox 74">
            <a:extLst>
              <a:ext uri="{FF2B5EF4-FFF2-40B4-BE49-F238E27FC236}">
                <a16:creationId xmlns:a16="http://schemas.microsoft.com/office/drawing/2014/main" id="{11AAE0C5-3F09-4F96-A712-A5135BA3F8C3}"/>
              </a:ext>
            </a:extLst>
          </p:cNvPr>
          <p:cNvSpPr txBox="1"/>
          <p:nvPr/>
        </p:nvSpPr>
        <p:spPr>
          <a:xfrm>
            <a:off x="3235757" y="40014"/>
            <a:ext cx="7146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Suppl. Data S2: N-glycan analysis of WT and </a:t>
            </a:r>
            <a:r>
              <a:rPr lang="en-GB" sz="1600" dirty="0">
                <a:latin typeface="Symbol" panose="05050102010706020507" pitchFamily="18" charset="2"/>
              </a:rPr>
              <a:t>D</a:t>
            </a:r>
            <a:r>
              <a:rPr lang="en-GB" sz="1600" dirty="0"/>
              <a:t>XF SIgA1 produced in </a:t>
            </a:r>
            <a:r>
              <a:rPr lang="en-GB" sz="1600" i="1" dirty="0"/>
              <a:t>N. </a:t>
            </a:r>
            <a:r>
              <a:rPr lang="en-GB" sz="1600" i="1" dirty="0" err="1"/>
              <a:t>benthamiana</a:t>
            </a:r>
            <a:endParaRPr lang="en-GB" sz="1600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36AE403E-9B19-4425-985C-89F4234F4519}"/>
              </a:ext>
            </a:extLst>
          </p:cNvPr>
          <p:cNvSpPr txBox="1"/>
          <p:nvPr/>
        </p:nvSpPr>
        <p:spPr>
          <a:xfrm>
            <a:off x="6572223" y="5356057"/>
            <a:ext cx="21214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Symbol" panose="05050102010706020507" pitchFamily="18" charset="2"/>
              </a:rPr>
              <a:t>D</a:t>
            </a:r>
          </a:p>
        </p:txBody>
      </p:sp>
      <p:pic>
        <p:nvPicPr>
          <p:cNvPr id="82" name="Picture 81">
            <a:extLst>
              <a:ext uri="{FF2B5EF4-FFF2-40B4-BE49-F238E27FC236}">
                <a16:creationId xmlns:a16="http://schemas.microsoft.com/office/drawing/2014/main" id="{217B7C60-D85B-4043-9282-AE5A4A9258A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71560" y="421460"/>
            <a:ext cx="2363577" cy="1498188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id="{844B258A-4011-455B-80BD-B13EC04F77C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96072" y="421461"/>
            <a:ext cx="2371928" cy="1479223"/>
          </a:xfrm>
          <a:prstGeom prst="rect">
            <a:avLst/>
          </a:prstGeom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7D12F1C4-929D-4058-9E56-8366D1653EA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68863" y="2046589"/>
            <a:ext cx="2329284" cy="1517152"/>
          </a:xfrm>
          <a:prstGeom prst="rect">
            <a:avLst/>
          </a:prstGeom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id="{CE3429FB-728B-45AF-A8B0-95ECA4F9926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305804" y="2053648"/>
            <a:ext cx="2349891" cy="1484068"/>
          </a:xfrm>
          <a:prstGeom prst="rect">
            <a:avLst/>
          </a:prstGeom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1F7A6A44-F204-4BC9-902A-9FFDFF2293F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265941" y="3713700"/>
            <a:ext cx="2363791" cy="1474614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6638F483-38D8-4239-9EF2-A3361E873AB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770619" y="3719461"/>
            <a:ext cx="2367960" cy="1465397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77F952D0-410B-49CB-A856-97304ABAC814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309971" y="3690682"/>
            <a:ext cx="2359622" cy="1479223"/>
          </a:xfrm>
          <a:prstGeom prst="rect">
            <a:avLst/>
          </a:prstGeom>
        </p:spPr>
      </p:pic>
      <p:pic>
        <p:nvPicPr>
          <p:cNvPr id="100" name="Picture 99">
            <a:extLst>
              <a:ext uri="{FF2B5EF4-FFF2-40B4-BE49-F238E27FC236}">
                <a16:creationId xmlns:a16="http://schemas.microsoft.com/office/drawing/2014/main" id="{295FF6BA-51C8-4C13-8D2A-43B9D120D1DC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782521" y="424254"/>
            <a:ext cx="2366167" cy="1492601"/>
          </a:xfrm>
          <a:prstGeom prst="rect">
            <a:avLst/>
          </a:prstGeom>
        </p:spPr>
      </p:pic>
      <p:pic>
        <p:nvPicPr>
          <p:cNvPr id="102" name="Picture 101">
            <a:extLst>
              <a:ext uri="{FF2B5EF4-FFF2-40B4-BE49-F238E27FC236}">
                <a16:creationId xmlns:a16="http://schemas.microsoft.com/office/drawing/2014/main" id="{0C4D443A-718C-4F84-9C8D-B36471C3B2BF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761892" y="2053648"/>
            <a:ext cx="2407423" cy="1517152"/>
          </a:xfrm>
          <a:prstGeom prst="rect">
            <a:avLst/>
          </a:prstGeom>
        </p:spPr>
      </p:pic>
      <p:pic>
        <p:nvPicPr>
          <p:cNvPr id="104" name="Picture 103">
            <a:extLst>
              <a:ext uri="{FF2B5EF4-FFF2-40B4-BE49-F238E27FC236}">
                <a16:creationId xmlns:a16="http://schemas.microsoft.com/office/drawing/2014/main" id="{87FA3AA5-94DE-4353-B852-096E724AD49A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265941" y="5322870"/>
            <a:ext cx="2363791" cy="1484067"/>
          </a:xfrm>
          <a:prstGeom prst="rect">
            <a:avLst/>
          </a:prstGeom>
        </p:spPr>
      </p:pic>
      <p:pic>
        <p:nvPicPr>
          <p:cNvPr id="106" name="Picture 105">
            <a:extLst>
              <a:ext uri="{FF2B5EF4-FFF2-40B4-BE49-F238E27FC236}">
                <a16:creationId xmlns:a16="http://schemas.microsoft.com/office/drawing/2014/main" id="{A9EC00F6-02C2-4168-A5F8-7121FB4D5BC1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766419" y="5333518"/>
            <a:ext cx="2382269" cy="1473419"/>
          </a:xfrm>
          <a:prstGeom prst="rect">
            <a:avLst/>
          </a:prstGeom>
        </p:spPr>
      </p:pic>
      <p:pic>
        <p:nvPicPr>
          <p:cNvPr id="110" name="Picture 109">
            <a:extLst>
              <a:ext uri="{FF2B5EF4-FFF2-40B4-BE49-F238E27FC236}">
                <a16:creationId xmlns:a16="http://schemas.microsoft.com/office/drawing/2014/main" id="{B8C79658-B347-4577-AB24-ECBDFB885EE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305804" y="5319306"/>
            <a:ext cx="2377053" cy="14840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0464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>
            <a:extLst>
              <a:ext uri="{FF2B5EF4-FFF2-40B4-BE49-F238E27FC236}">
                <a16:creationId xmlns:a16="http://schemas.microsoft.com/office/drawing/2014/main" id="{11AAE0C5-3F09-4F96-A712-A5135BA3F8C3}"/>
              </a:ext>
            </a:extLst>
          </p:cNvPr>
          <p:cNvSpPr txBox="1"/>
          <p:nvPr/>
        </p:nvSpPr>
        <p:spPr>
          <a:xfrm>
            <a:off x="3235757" y="40014"/>
            <a:ext cx="7146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/>
              <a:t>Suppl. Data S3: N-glycan analysis of WT and </a:t>
            </a:r>
            <a:r>
              <a:rPr lang="en-GB" sz="1600" dirty="0">
                <a:latin typeface="Symbol" panose="05050102010706020507" pitchFamily="18" charset="2"/>
              </a:rPr>
              <a:t>D</a:t>
            </a:r>
            <a:r>
              <a:rPr lang="en-GB" sz="1600" dirty="0"/>
              <a:t>XF SIgA2 produced in </a:t>
            </a:r>
            <a:r>
              <a:rPr lang="en-GB" sz="1600" i="1" dirty="0"/>
              <a:t>N. </a:t>
            </a:r>
            <a:r>
              <a:rPr lang="en-GB" sz="1600" i="1" dirty="0" err="1"/>
              <a:t>benthamiana</a:t>
            </a:r>
            <a:endParaRPr lang="en-GB" sz="1600" dirty="0"/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818D987E-6832-4A6B-A104-3740444DD273}"/>
              </a:ext>
            </a:extLst>
          </p:cNvPr>
          <p:cNvGrpSpPr/>
          <p:nvPr/>
        </p:nvGrpSpPr>
        <p:grpSpPr>
          <a:xfrm>
            <a:off x="3247168" y="423975"/>
            <a:ext cx="7420833" cy="1498187"/>
            <a:chOff x="1303314" y="421841"/>
            <a:chExt cx="7420833" cy="1498187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1B19D066-3AFC-43A1-BE14-4033D65107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03314" y="421841"/>
              <a:ext cx="2425703" cy="148888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76F42691-BE14-4371-BB50-2EFCE3B7855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90165" y="421841"/>
              <a:ext cx="2434274" cy="1498187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2A8F308E-D0D6-49ED-814F-0666B68E085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285587" y="421841"/>
              <a:ext cx="2438560" cy="1488882"/>
            </a:xfrm>
            <a:prstGeom prst="rect">
              <a:avLst/>
            </a:prstGeom>
          </p:spPr>
        </p:pic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id="{90C80812-4F7B-415A-8C19-992084B2683A}"/>
              </a:ext>
            </a:extLst>
          </p:cNvPr>
          <p:cNvGrpSpPr/>
          <p:nvPr/>
        </p:nvGrpSpPr>
        <p:grpSpPr>
          <a:xfrm>
            <a:off x="3235758" y="2008219"/>
            <a:ext cx="7432243" cy="1502841"/>
            <a:chOff x="1711757" y="2080479"/>
            <a:chExt cx="7432243" cy="1502841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14D0C94C-B234-4FC1-90BF-370D2A78D3C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711757" y="2080479"/>
              <a:ext cx="2429974" cy="1474923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E02503F0-1267-4056-B447-F76B2F5AD0A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206452" y="2080479"/>
              <a:ext cx="2434267" cy="1502841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348D2175-C2BC-4466-99AB-B5F32EDC398A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705440" y="2080479"/>
              <a:ext cx="2438560" cy="1488882"/>
            </a:xfrm>
            <a:prstGeom prst="rect">
              <a:avLst/>
            </a:prstGeom>
          </p:spPr>
        </p:pic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id="{36F87C90-5953-439D-9E2F-A5B8DF017DB3}"/>
              </a:ext>
            </a:extLst>
          </p:cNvPr>
          <p:cNvGrpSpPr/>
          <p:nvPr/>
        </p:nvGrpSpPr>
        <p:grpSpPr>
          <a:xfrm>
            <a:off x="3222872" y="3597117"/>
            <a:ext cx="7445129" cy="1565495"/>
            <a:chOff x="1698871" y="3623531"/>
            <a:chExt cx="7445129" cy="1565495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0E4D70E6-6527-4B47-8558-49BA22CC21F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698871" y="3623531"/>
              <a:ext cx="2442860" cy="1565494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FAC9B5CB-4289-423C-B836-189BFA288CE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705440" y="3623531"/>
              <a:ext cx="2438560" cy="1565495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1DB1C5E6-DF8B-48F8-AB0C-80DC164B8F1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204305" y="3623531"/>
              <a:ext cx="2438560" cy="1565494"/>
            </a:xfrm>
            <a:prstGeom prst="rect">
              <a:avLst/>
            </a:prstGeom>
          </p:spPr>
        </p:pic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C1C6B946-BAC5-4267-9CCC-C7BA8FC4A1A8}"/>
              </a:ext>
            </a:extLst>
          </p:cNvPr>
          <p:cNvGrpSpPr/>
          <p:nvPr/>
        </p:nvGrpSpPr>
        <p:grpSpPr>
          <a:xfrm>
            <a:off x="3222871" y="5248667"/>
            <a:ext cx="7440928" cy="1565494"/>
            <a:chOff x="1698871" y="5248667"/>
            <a:chExt cx="7440928" cy="1565494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E26CACCA-A78A-4190-99C7-8BA615C91352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698871" y="5248667"/>
              <a:ext cx="2425818" cy="1560617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9E20B42C-9A79-4CBF-9AAC-88607C3A599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202155" y="5248667"/>
              <a:ext cx="2425818" cy="1560617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F4EC024A-996E-4851-84CD-182EDFCAF82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6705440" y="5248667"/>
              <a:ext cx="2434359" cy="1565494"/>
            </a:xfrm>
            <a:prstGeom prst="rect">
              <a:avLst/>
            </a:prstGeom>
          </p:spPr>
        </p:pic>
      </p:grpSp>
      <p:pic>
        <p:nvPicPr>
          <p:cNvPr id="46" name="Picture 45">
            <a:extLst>
              <a:ext uri="{FF2B5EF4-FFF2-40B4-BE49-F238E27FC236}">
                <a16:creationId xmlns:a16="http://schemas.microsoft.com/office/drawing/2014/main" id="{C0C18A32-4B07-4003-965E-B194B2862B45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810144" y="267945"/>
            <a:ext cx="1309209" cy="1654216"/>
          </a:xfrm>
          <a:prstGeom prst="rect">
            <a:avLst/>
          </a:prstGeom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69021782-1332-420E-BE20-829856ED1F7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810143" y="1942900"/>
            <a:ext cx="1309209" cy="1654216"/>
          </a:xfrm>
          <a:prstGeom prst="rect">
            <a:avLst/>
          </a:prstGeom>
        </p:spPr>
      </p:pic>
      <p:pic>
        <p:nvPicPr>
          <p:cNvPr id="80" name="Picture 79">
            <a:extLst>
              <a:ext uri="{FF2B5EF4-FFF2-40B4-BE49-F238E27FC236}">
                <a16:creationId xmlns:a16="http://schemas.microsoft.com/office/drawing/2014/main" id="{9C8A4E51-AE26-4CF2-8D9D-7A274354C373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806839" y="3749011"/>
            <a:ext cx="1312512" cy="1252667"/>
          </a:xfrm>
          <a:prstGeom prst="rect">
            <a:avLst/>
          </a:prstGeom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id="{9E418A39-675A-4AD5-84F6-1895DAADBF5F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806839" y="5531059"/>
            <a:ext cx="1312512" cy="948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07659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95A0364-588C-4705-BBEF-D24DEA1CB3C3}"/>
              </a:ext>
            </a:extLst>
          </p:cNvPr>
          <p:cNvSpPr txBox="1"/>
          <p:nvPr/>
        </p:nvSpPr>
        <p:spPr>
          <a:xfrm>
            <a:off x="1687551" y="200723"/>
            <a:ext cx="2512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uppl. data S4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502514A-0DFF-42B4-B377-470F71B4DA0C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8719" y="1547012"/>
            <a:ext cx="5486400" cy="3208020"/>
          </a:xfrm>
          <a:prstGeom prst="rect">
            <a:avLst/>
          </a:prstGeom>
        </p:spPr>
      </p:pic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54C1D08E-E0B3-42E6-BE78-842859AAA8C9}"/>
              </a:ext>
            </a:extLst>
          </p:cNvPr>
          <p:cNvGraphicFramePr>
            <a:graphicFrameLocks noGrp="1"/>
          </p:cNvGraphicFramePr>
          <p:nvPr/>
        </p:nvGraphicFramePr>
        <p:xfrm>
          <a:off x="1984807" y="2016741"/>
          <a:ext cx="2501900" cy="2667000"/>
        </p:xfrm>
        <a:graphic>
          <a:graphicData uri="http://schemas.openxmlformats.org/drawingml/2006/table">
            <a:tbl>
              <a:tblPr firstRow="1" firstCol="1" bandRow="1"/>
              <a:tblGrid>
                <a:gridCol w="901700">
                  <a:extLst>
                    <a:ext uri="{9D8B030D-6E8A-4147-A177-3AD203B41FA5}">
                      <a16:colId xmlns:a16="http://schemas.microsoft.com/office/drawing/2014/main" val="4285469802"/>
                    </a:ext>
                  </a:extLst>
                </a:gridCol>
                <a:gridCol w="800100">
                  <a:extLst>
                    <a:ext uri="{9D8B030D-6E8A-4147-A177-3AD203B41FA5}">
                      <a16:colId xmlns:a16="http://schemas.microsoft.com/office/drawing/2014/main" val="4238260214"/>
                    </a:ext>
                  </a:extLst>
                </a:gridCol>
                <a:gridCol w="800100">
                  <a:extLst>
                    <a:ext uri="{9D8B030D-6E8A-4147-A177-3AD203B41FA5}">
                      <a16:colId xmlns:a16="http://schemas.microsoft.com/office/drawing/2014/main" val="369569793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IgA1_wt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IgA1_DXF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80072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glyc 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9.29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9.69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88408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60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99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645633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.46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8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5078794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92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23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215098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37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.90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898317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65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32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40464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.24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16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577999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3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05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560261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59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39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897026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49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4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126490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85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45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622771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1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1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0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478000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 Arabinose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2</a:t>
                      </a:r>
                      <a:endParaRPr lang="en-GB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1</a:t>
                      </a:r>
                      <a:endParaRPr lang="en-GB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7418771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1B6E3E5-0A74-465D-BF89-8091B1316CCA}"/>
              </a:ext>
            </a:extLst>
          </p:cNvPr>
          <p:cNvSpPr txBox="1"/>
          <p:nvPr/>
        </p:nvSpPr>
        <p:spPr>
          <a:xfrm>
            <a:off x="2994046" y="231891"/>
            <a:ext cx="67650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u="sng" dirty="0"/>
              <a:t>O-glycan analysis of WT and </a:t>
            </a:r>
            <a:r>
              <a:rPr lang="en-GB" u="sng" dirty="0" err="1"/>
              <a:t>dXF</a:t>
            </a:r>
            <a:r>
              <a:rPr lang="en-GB" u="sng" dirty="0"/>
              <a:t> SIgA1 produced in </a:t>
            </a:r>
            <a:r>
              <a:rPr lang="en-GB" i="1" u="sng" dirty="0"/>
              <a:t>N. </a:t>
            </a:r>
            <a:r>
              <a:rPr lang="en-GB" i="1" u="sng" dirty="0" err="1"/>
              <a:t>benthamiana</a:t>
            </a:r>
            <a:endParaRPr lang="en-GB" i="1" u="sng" dirty="0"/>
          </a:p>
        </p:txBody>
      </p:sp>
    </p:spTree>
    <p:extLst>
      <p:ext uri="{BB962C8B-B14F-4D97-AF65-F5344CB8AC3E}">
        <p14:creationId xmlns:p14="http://schemas.microsoft.com/office/powerpoint/2010/main" val="2351536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4</Words>
  <Application>Microsoft Office PowerPoint</Application>
  <PresentationFormat>Widescreen</PresentationFormat>
  <Paragraphs>57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Times New Roman</vt:lpstr>
      <vt:lpstr>Office Theme</vt:lpstr>
      <vt:lpstr>Graph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ha Thangaraj, Integra-PDY, IN</dc:creator>
  <cp:lastModifiedBy>Usha Thangaraj, Integra-PDY, IN</cp:lastModifiedBy>
  <cp:revision>1</cp:revision>
  <dcterms:created xsi:type="dcterms:W3CDTF">2021-01-12T05:02:21Z</dcterms:created>
  <dcterms:modified xsi:type="dcterms:W3CDTF">2021-01-12T05:02:57Z</dcterms:modified>
</cp:coreProperties>
</file>